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  <p:sldId id="265" r:id="rId3"/>
    <p:sldId id="266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9D18E"/>
    <a:srgbClr val="FF727D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2"/>
    <p:restoredTop sz="94674"/>
  </p:normalViewPr>
  <p:slideViewPr>
    <p:cSldViewPr snapToGrid="0" snapToObjects="1">
      <p:cViewPr varScale="1">
        <p:scale>
          <a:sx n="79" d="100"/>
          <a:sy n="79" d="100"/>
        </p:scale>
        <p:origin x="246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liuxi\Documents\Lab%20Operation\Projects\SolSqua\RawData\&#36716;&#24405;&#32452;&#19978;&#35843;&#22522;&#22240;&#34920;&#36798;qPCR&#20998;&#26512;\zlzqpcr-5F_5R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liuxi\Documents\Lab%20Operation\Projects\SolSqua\RawData\&#36716;&#24405;&#32452;&#19978;&#35843;&#22522;&#22240;&#34920;&#36798;qPCR&#20998;&#26512;\zlzqpcr-1F_1R_data.xls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liuxi\Documents\Lab%20Operation\Projects\SolSqua\RawData\&#36716;&#24405;&#32452;&#19978;&#35843;&#22522;&#22240;&#34920;&#36798;qPCR&#20998;&#26512;\zlzqpcr-15F1_15R1.xls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liuxi\Documents\Lab%20Operation\Projects\SolSqua\RawData\&#36716;&#24405;&#32452;&#19978;&#35843;&#22522;&#22240;&#34920;&#36798;qPCR&#20998;&#26512;\zlzqpcr-14F_14R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E9C-40C6-A5A7-D0EA1FEE1586}"/>
              </c:ext>
            </c:extLst>
          </c:dPt>
          <c:errBars>
            <c:errBarType val="both"/>
            <c:errValType val="cust"/>
            <c:noEndCap val="0"/>
            <c:plus>
              <c:numRef>
                <c:f>'5'!$C$36:$C$41</c:f>
                <c:numCache>
                  <c:formatCode>General</c:formatCode>
                  <c:ptCount val="6"/>
                  <c:pt idx="0">
                    <c:v>0.38670841976639408</c:v>
                  </c:pt>
                  <c:pt idx="1">
                    <c:v>0.97385740231538453</c:v>
                  </c:pt>
                  <c:pt idx="2">
                    <c:v>2.1142419718301015E-2</c:v>
                  </c:pt>
                  <c:pt idx="3">
                    <c:v>0.11965017391868532</c:v>
                  </c:pt>
                  <c:pt idx="4">
                    <c:v>0.23084565633360893</c:v>
                  </c:pt>
                  <c:pt idx="5">
                    <c:v>0.18677931467285136</c:v>
                  </c:pt>
                </c:numCache>
              </c:numRef>
            </c:plus>
            <c:minus>
              <c:numRef>
                <c:f>'5'!$C$36:$C$41</c:f>
                <c:numCache>
                  <c:formatCode>General</c:formatCode>
                  <c:ptCount val="6"/>
                  <c:pt idx="0">
                    <c:v>0.38670841976639408</c:v>
                  </c:pt>
                  <c:pt idx="1">
                    <c:v>0.97385740231538453</c:v>
                  </c:pt>
                  <c:pt idx="2">
                    <c:v>2.1142419718301015E-2</c:v>
                  </c:pt>
                  <c:pt idx="3">
                    <c:v>0.11965017391868532</c:v>
                  </c:pt>
                  <c:pt idx="4">
                    <c:v>0.23084565633360893</c:v>
                  </c:pt>
                  <c:pt idx="5">
                    <c:v>0.186779314672851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5'!$A$36:$A$41</c:f>
              <c:strCache>
                <c:ptCount val="6"/>
                <c:pt idx="0">
                  <c:v>WT</c:v>
                </c:pt>
                <c:pt idx="1">
                  <c:v>NbSQS-OE 12-8-2 1</c:v>
                </c:pt>
                <c:pt idx="2">
                  <c:v>NbSQS-OE 12-8-2 2</c:v>
                </c:pt>
                <c:pt idx="3">
                  <c:v>NbSQS-OE 12-8-2 3</c:v>
                </c:pt>
                <c:pt idx="4">
                  <c:v>NbSQS-OE 12-8-2 4</c:v>
                </c:pt>
                <c:pt idx="5">
                  <c:v>NbSQS-OE 12-8-2 6</c:v>
                </c:pt>
              </c:strCache>
            </c:strRef>
          </c:cat>
          <c:val>
            <c:numRef>
              <c:f>'5'!$B$36:$B$41</c:f>
              <c:numCache>
                <c:formatCode>General</c:formatCode>
                <c:ptCount val="6"/>
                <c:pt idx="0">
                  <c:v>1.0612436098211215</c:v>
                </c:pt>
                <c:pt idx="1">
                  <c:v>5.9860090397757411</c:v>
                </c:pt>
                <c:pt idx="2">
                  <c:v>1.8875575373987432</c:v>
                </c:pt>
                <c:pt idx="3">
                  <c:v>1.9188630451090383</c:v>
                </c:pt>
                <c:pt idx="4">
                  <c:v>2.3088136193973368</c:v>
                </c:pt>
                <c:pt idx="5">
                  <c:v>3.30433223183647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9C-40C6-A5A7-D0EA1FEE15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0"/>
        <c:axId val="2058282176"/>
        <c:axId val="2058277600"/>
      </c:barChart>
      <c:catAx>
        <c:axId val="2058282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58277600"/>
        <c:crosses val="autoZero"/>
        <c:auto val="1"/>
        <c:lblAlgn val="ctr"/>
        <c:lblOffset val="100"/>
        <c:noMultiLvlLbl val="0"/>
      </c:catAx>
      <c:valAx>
        <c:axId val="20582776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/>
                  <a:t>Relative Expression</a:t>
                </a:r>
                <a:endParaRPr lang="zh-CN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58282176"/>
        <c:crosses val="autoZero"/>
        <c:crossBetween val="between"/>
        <c:majorUnit val="2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5256157809275509"/>
          <c:y val="5.5201255428070223E-2"/>
          <c:w val="0.69500198560306403"/>
          <c:h val="0.521009435662866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73A-4444-B122-D6B3C0EF6860}"/>
              </c:ext>
            </c:extLst>
          </c:dPt>
          <c:errBars>
            <c:errBarType val="both"/>
            <c:errValType val="cust"/>
            <c:noEndCap val="0"/>
            <c:plus>
              <c:numRef>
                <c:f>'1'!$C$35:$C$40</c:f>
                <c:numCache>
                  <c:formatCode>General</c:formatCode>
                  <c:ptCount val="6"/>
                  <c:pt idx="0">
                    <c:v>0.42775247693045071</c:v>
                  </c:pt>
                  <c:pt idx="1">
                    <c:v>5.614151001968648</c:v>
                  </c:pt>
                  <c:pt idx="2">
                    <c:v>0.24149079247258082</c:v>
                  </c:pt>
                  <c:pt idx="3">
                    <c:v>2.686724962031287</c:v>
                  </c:pt>
                  <c:pt idx="4">
                    <c:v>1.2279224162038889</c:v>
                  </c:pt>
                  <c:pt idx="5">
                    <c:v>1.5519261618290263</c:v>
                  </c:pt>
                </c:numCache>
              </c:numRef>
            </c:plus>
            <c:minus>
              <c:numRef>
                <c:f>'1'!$C$35:$C$40</c:f>
                <c:numCache>
                  <c:formatCode>General</c:formatCode>
                  <c:ptCount val="6"/>
                  <c:pt idx="0">
                    <c:v>0.42775247693045071</c:v>
                  </c:pt>
                  <c:pt idx="1">
                    <c:v>5.614151001968648</c:v>
                  </c:pt>
                  <c:pt idx="2">
                    <c:v>0.24149079247258082</c:v>
                  </c:pt>
                  <c:pt idx="3">
                    <c:v>2.686724962031287</c:v>
                  </c:pt>
                  <c:pt idx="4">
                    <c:v>1.2279224162038889</c:v>
                  </c:pt>
                  <c:pt idx="5">
                    <c:v>1.55192616182902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1'!$A$35:$A$40</c:f>
              <c:strCache>
                <c:ptCount val="6"/>
                <c:pt idx="0">
                  <c:v>WT</c:v>
                </c:pt>
                <c:pt idx="1">
                  <c:v>NbSQS-12-8-2 1</c:v>
                </c:pt>
                <c:pt idx="2">
                  <c:v>NbSQS-12-8-2 2</c:v>
                </c:pt>
                <c:pt idx="3">
                  <c:v>NbSQS-12-8-2 3</c:v>
                </c:pt>
                <c:pt idx="4">
                  <c:v>NbSQS-12-8-2 4</c:v>
                </c:pt>
                <c:pt idx="5">
                  <c:v>NbSQS-12-8-2 6</c:v>
                </c:pt>
              </c:strCache>
            </c:strRef>
          </c:cat>
          <c:val>
            <c:numRef>
              <c:f>'1'!$B$35:$B$40</c:f>
              <c:numCache>
                <c:formatCode>General</c:formatCode>
                <c:ptCount val="6"/>
                <c:pt idx="0">
                  <c:v>1.0809912281353247</c:v>
                </c:pt>
                <c:pt idx="1">
                  <c:v>14.071637936066333</c:v>
                </c:pt>
                <c:pt idx="2">
                  <c:v>2.8298806152180784</c:v>
                </c:pt>
                <c:pt idx="3">
                  <c:v>5.1929410305388011</c:v>
                </c:pt>
                <c:pt idx="4">
                  <c:v>3.0360044504763146</c:v>
                </c:pt>
                <c:pt idx="5">
                  <c:v>5.6221976335264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3A-4444-B122-D6B3C0EF68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58282176"/>
        <c:axId val="2058277600"/>
      </c:barChart>
      <c:catAx>
        <c:axId val="2058282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58277600"/>
        <c:crosses val="autoZero"/>
        <c:auto val="1"/>
        <c:lblAlgn val="ctr"/>
        <c:lblOffset val="100"/>
        <c:noMultiLvlLbl val="0"/>
      </c:catAx>
      <c:valAx>
        <c:axId val="20582776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/>
                  <a:t>Relative Expression</a:t>
                </a:r>
                <a:endParaRPr lang="zh-CN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58282176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258-46FB-AE57-35ED2CD43E18}"/>
              </c:ext>
            </c:extLst>
          </c:dPt>
          <c:errBars>
            <c:errBarType val="both"/>
            <c:errValType val="cust"/>
            <c:noEndCap val="0"/>
            <c:plus>
              <c:numRef>
                <c:f>'15'!$C$36:$C$41</c:f>
                <c:numCache>
                  <c:formatCode>General</c:formatCode>
                  <c:ptCount val="6"/>
                  <c:pt idx="0">
                    <c:v>0.64249780000000001</c:v>
                  </c:pt>
                  <c:pt idx="1">
                    <c:v>2.2888627000000002E-2</c:v>
                  </c:pt>
                  <c:pt idx="2">
                    <c:v>5.8712540000000002E-3</c:v>
                  </c:pt>
                  <c:pt idx="3">
                    <c:v>7.8906689999999995E-3</c:v>
                  </c:pt>
                  <c:pt idx="4">
                    <c:v>6.285634E-3</c:v>
                  </c:pt>
                  <c:pt idx="5">
                    <c:v>1.2904211000000001E-2</c:v>
                  </c:pt>
                </c:numCache>
              </c:numRef>
            </c:plus>
            <c:minus>
              <c:numRef>
                <c:f>'15'!$C$36:$C$41</c:f>
                <c:numCache>
                  <c:formatCode>General</c:formatCode>
                  <c:ptCount val="6"/>
                  <c:pt idx="0">
                    <c:v>0.64249780000000001</c:v>
                  </c:pt>
                  <c:pt idx="1">
                    <c:v>2.2888627000000002E-2</c:v>
                  </c:pt>
                  <c:pt idx="2">
                    <c:v>5.8712540000000002E-3</c:v>
                  </c:pt>
                  <c:pt idx="3">
                    <c:v>7.8906689999999995E-3</c:v>
                  </c:pt>
                  <c:pt idx="4">
                    <c:v>6.285634E-3</c:v>
                  </c:pt>
                  <c:pt idx="5">
                    <c:v>1.2904211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15'!$A$36:$A$41</c:f>
              <c:strCache>
                <c:ptCount val="6"/>
                <c:pt idx="0">
                  <c:v>WT</c:v>
                </c:pt>
                <c:pt idx="1">
                  <c:v>NbSQS-OE 12-8-2 1</c:v>
                </c:pt>
                <c:pt idx="2">
                  <c:v>NbSQS-OE 12-8-2 2</c:v>
                </c:pt>
                <c:pt idx="3">
                  <c:v>NbSQS-OE 12-8-2 3</c:v>
                </c:pt>
                <c:pt idx="4">
                  <c:v>NbSQS-OE 12-8-2 4</c:v>
                </c:pt>
                <c:pt idx="5">
                  <c:v>NbSQS-OE 12-8-2 6</c:v>
                </c:pt>
              </c:strCache>
            </c:strRef>
          </c:cat>
          <c:val>
            <c:numRef>
              <c:f>'15'!$B$36:$B$41</c:f>
              <c:numCache>
                <c:formatCode>General</c:formatCode>
                <c:ptCount val="6"/>
                <c:pt idx="0">
                  <c:v>1.1597678410000001</c:v>
                </c:pt>
                <c:pt idx="1">
                  <c:v>0.108953038</c:v>
                </c:pt>
                <c:pt idx="2">
                  <c:v>8.1402014999999994E-2</c:v>
                </c:pt>
                <c:pt idx="3">
                  <c:v>0.128407524</c:v>
                </c:pt>
                <c:pt idx="4">
                  <c:v>7.5857586000000005E-2</c:v>
                </c:pt>
                <c:pt idx="5">
                  <c:v>0.2084812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58-46FB-AE57-35ED2CD43E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0"/>
        <c:axId val="2058282176"/>
        <c:axId val="2058277600"/>
      </c:barChart>
      <c:catAx>
        <c:axId val="2058282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58277600"/>
        <c:crosses val="autoZero"/>
        <c:auto val="1"/>
        <c:lblAlgn val="ctr"/>
        <c:lblOffset val="100"/>
        <c:noMultiLvlLbl val="0"/>
      </c:catAx>
      <c:valAx>
        <c:axId val="20582776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/>
                  <a:t>Relative Expression</a:t>
                </a:r>
                <a:endParaRPr lang="zh-CN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58282176"/>
        <c:crosses val="autoZero"/>
        <c:crossBetween val="between"/>
        <c:majorUnit val="0.5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D84-414B-844D-A95ECDEC7614}"/>
              </c:ext>
            </c:extLst>
          </c:dPt>
          <c:errBars>
            <c:errBarType val="both"/>
            <c:errValType val="cust"/>
            <c:noEndCap val="0"/>
            <c:plus>
              <c:numRef>
                <c:f>'14'!$C$36:$C$41</c:f>
                <c:numCache>
                  <c:formatCode>General</c:formatCode>
                  <c:ptCount val="6"/>
                  <c:pt idx="0">
                    <c:v>0.63196164867432314</c:v>
                  </c:pt>
                  <c:pt idx="1">
                    <c:v>7.7126750175525068E-3</c:v>
                  </c:pt>
                  <c:pt idx="2">
                    <c:v>1.5817445190281804E-2</c:v>
                  </c:pt>
                  <c:pt idx="3">
                    <c:v>1.3194380321998935E-2</c:v>
                  </c:pt>
                  <c:pt idx="4">
                    <c:v>1.0997076020211386E-2</c:v>
                  </c:pt>
                  <c:pt idx="5">
                    <c:v>1.3888892339004087E-2</c:v>
                  </c:pt>
                </c:numCache>
              </c:numRef>
            </c:plus>
            <c:minus>
              <c:numRef>
                <c:f>'14'!$C$36:$C$41</c:f>
                <c:numCache>
                  <c:formatCode>General</c:formatCode>
                  <c:ptCount val="6"/>
                  <c:pt idx="0">
                    <c:v>0.63196164867432314</c:v>
                  </c:pt>
                  <c:pt idx="1">
                    <c:v>7.7126750175525068E-3</c:v>
                  </c:pt>
                  <c:pt idx="2">
                    <c:v>1.5817445190281804E-2</c:v>
                  </c:pt>
                  <c:pt idx="3">
                    <c:v>1.3194380321998935E-2</c:v>
                  </c:pt>
                  <c:pt idx="4">
                    <c:v>1.0997076020211386E-2</c:v>
                  </c:pt>
                  <c:pt idx="5">
                    <c:v>1.388889233900408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14'!$A$36:$A$41</c:f>
              <c:strCache>
                <c:ptCount val="6"/>
                <c:pt idx="0">
                  <c:v>WT</c:v>
                </c:pt>
                <c:pt idx="1">
                  <c:v>NbSQS-OE 12-8-2 1</c:v>
                </c:pt>
                <c:pt idx="2">
                  <c:v>NbSQS-OE 12-8-2 2</c:v>
                </c:pt>
                <c:pt idx="3">
                  <c:v>NbSQS-OE 12-8-2 3</c:v>
                </c:pt>
                <c:pt idx="4">
                  <c:v>NbSQS-OE 12-8-2 4</c:v>
                </c:pt>
                <c:pt idx="5">
                  <c:v>NbSQS-OE 12-8-2 6</c:v>
                </c:pt>
              </c:strCache>
            </c:strRef>
          </c:cat>
          <c:val>
            <c:numRef>
              <c:f>'14'!$B$36:$B$41</c:f>
              <c:numCache>
                <c:formatCode>General</c:formatCode>
                <c:ptCount val="6"/>
                <c:pt idx="0">
                  <c:v>1.1505494137471723</c:v>
                </c:pt>
                <c:pt idx="1">
                  <c:v>0.10687082719604141</c:v>
                </c:pt>
                <c:pt idx="2">
                  <c:v>8.8636883408394304E-2</c:v>
                </c:pt>
                <c:pt idx="3">
                  <c:v>0.13760439145388978</c:v>
                </c:pt>
                <c:pt idx="4">
                  <c:v>9.2780208268722519E-2</c:v>
                </c:pt>
                <c:pt idx="5">
                  <c:v>0.171549329653914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D84-414B-844D-A95ECDEC76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0"/>
        <c:axId val="2058282176"/>
        <c:axId val="2058277600"/>
      </c:barChart>
      <c:catAx>
        <c:axId val="2058282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58277600"/>
        <c:crosses val="autoZero"/>
        <c:auto val="1"/>
        <c:lblAlgn val="ctr"/>
        <c:lblOffset val="100"/>
        <c:noMultiLvlLbl val="0"/>
      </c:catAx>
      <c:valAx>
        <c:axId val="20582776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/>
                  <a:t>Relative Expression</a:t>
                </a:r>
                <a:endParaRPr lang="zh-CN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058282176"/>
        <c:crosses val="autoZero"/>
        <c:crossBetween val="between"/>
        <c:majorUnit val="0.5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  <c:extLst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439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219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458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172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916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115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340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334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057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402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397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58582D-0AFA-D74B-A8BB-8D37F8F78B76}" type="datetimeFigureOut">
              <a:rPr lang="en-US" smtClean="0"/>
              <a:t>2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8A7B80-9DAE-5F4B-ADBF-105CAFE18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750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13" Type="http://schemas.openxmlformats.org/officeDocument/2006/relationships/image" Target="../media/image15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12" Type="http://schemas.openxmlformats.org/officeDocument/2006/relationships/image" Target="../media/image14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11" Type="http://schemas.openxmlformats.org/officeDocument/2006/relationships/image" Target="../media/image13.emf"/><Relationship Id="rId5" Type="http://schemas.openxmlformats.org/officeDocument/2006/relationships/image" Target="../media/image7.emf"/><Relationship Id="rId10" Type="http://schemas.openxmlformats.org/officeDocument/2006/relationships/image" Target="../media/image12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041">
            <a:extLst>
              <a:ext uri="{FF2B5EF4-FFF2-40B4-BE49-F238E27FC236}">
                <a16:creationId xmlns:a16="http://schemas.microsoft.com/office/drawing/2014/main" id="{B33BC7C3-F84A-8743-0647-A2ACE5254800}"/>
              </a:ext>
            </a:extLst>
          </p:cNvPr>
          <p:cNvSpPr txBox="1"/>
          <p:nvPr/>
        </p:nvSpPr>
        <p:spPr>
          <a:xfrm>
            <a:off x="334885" y="5018528"/>
            <a:ext cx="6351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Transient VIGS of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NbSQ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induces meristematic lethality.</a:t>
            </a:r>
            <a:endParaRPr lang="en-US" sz="1200" b="1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B3F86CC8-2289-0DE4-A842-1B46FEFB789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807" t="23041" r="29068" b="11466"/>
          <a:stretch/>
        </p:blipFill>
        <p:spPr>
          <a:xfrm>
            <a:off x="259400" y="1889264"/>
            <a:ext cx="2121034" cy="268273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C333C82-A43F-EDBC-6EB4-3AC817E5C662}"/>
              </a:ext>
            </a:extLst>
          </p:cNvPr>
          <p:cNvSpPr txBox="1"/>
          <p:nvPr/>
        </p:nvSpPr>
        <p:spPr>
          <a:xfrm>
            <a:off x="259400" y="4592449"/>
            <a:ext cx="212103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mpty Vecto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A997412C-D2A6-B7AD-1EF3-FDB26168CE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4805" y="1889265"/>
            <a:ext cx="2012052" cy="268273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6CF860C9-E11B-2E4C-BE51-B9E7EF52596E}"/>
              </a:ext>
            </a:extLst>
          </p:cNvPr>
          <p:cNvSpPr txBox="1"/>
          <p:nvPr/>
        </p:nvSpPr>
        <p:spPr>
          <a:xfrm>
            <a:off x="2504804" y="4574396"/>
            <a:ext cx="19966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bSQS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VIGS</a:t>
            </a:r>
            <a:endParaRPr lang="zh-CN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62A1DB7C-2AC7-197F-5650-4D107C6F471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015" t="15120" r="22385" b="20278"/>
          <a:stretch/>
        </p:blipFill>
        <p:spPr>
          <a:xfrm>
            <a:off x="4641229" y="1889265"/>
            <a:ext cx="1851020" cy="2685131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2C363305-0CA6-9DCE-97B0-21E149993143}"/>
              </a:ext>
            </a:extLst>
          </p:cNvPr>
          <p:cNvSpPr txBox="1"/>
          <p:nvPr/>
        </p:nvSpPr>
        <p:spPr>
          <a:xfrm>
            <a:off x="4553019" y="4567899"/>
            <a:ext cx="193923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bPDS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VIGS</a:t>
            </a:r>
            <a:endParaRPr lang="zh-CN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52139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图表 14">
            <a:extLst>
              <a:ext uri="{FF2B5EF4-FFF2-40B4-BE49-F238E27FC236}">
                <a16:creationId xmlns:a16="http://schemas.microsoft.com/office/drawing/2014/main" id="{D867376D-6CF7-F2AB-1A56-32FB3D0190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8969113"/>
              </p:ext>
            </p:extLst>
          </p:nvPr>
        </p:nvGraphicFramePr>
        <p:xfrm>
          <a:off x="3138883" y="1194449"/>
          <a:ext cx="2662877" cy="28735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1041">
            <a:extLst>
              <a:ext uri="{FF2B5EF4-FFF2-40B4-BE49-F238E27FC236}">
                <a16:creationId xmlns:a16="http://schemas.microsoft.com/office/drawing/2014/main" id="{B33BC7C3-F84A-8743-0647-A2ACE5254800}"/>
              </a:ext>
            </a:extLst>
          </p:cNvPr>
          <p:cNvSpPr txBox="1"/>
          <p:nvPr/>
        </p:nvSpPr>
        <p:spPr>
          <a:xfrm>
            <a:off x="259400" y="7174156"/>
            <a:ext cx="63518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2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Q-RT-PCR validation of selected differentially expressed genes identified through comparative transcriptomics analyses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* p &lt; 0.05, Student’s 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t-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tests compared to wildtype (WT) controls. N = 3; error bars = standard deviations.</a:t>
            </a:r>
            <a:endParaRPr lang="en-US" sz="1200" b="1" dirty="0"/>
          </a:p>
        </p:txBody>
      </p:sp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0320B787-E609-EA42-EC40-4C02653A4F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9946005"/>
              </p:ext>
            </p:extLst>
          </p:nvPr>
        </p:nvGraphicFramePr>
        <p:xfrm>
          <a:off x="512914" y="1194450"/>
          <a:ext cx="2664178" cy="28735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7628E89A-03A2-2D58-8A37-E196A46677E0}"/>
              </a:ext>
            </a:extLst>
          </p:cNvPr>
          <p:cNvSpPr txBox="1"/>
          <p:nvPr/>
        </p:nvSpPr>
        <p:spPr>
          <a:xfrm>
            <a:off x="1540202" y="1381262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A5F73C5-5ACE-7F02-0977-A9C0FE70E588}"/>
              </a:ext>
            </a:extLst>
          </p:cNvPr>
          <p:cNvSpPr txBox="1"/>
          <p:nvPr/>
        </p:nvSpPr>
        <p:spPr>
          <a:xfrm>
            <a:off x="1845002" y="2333679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31FAE13-A7DD-C9B9-52B7-F9AD1AE44F21}"/>
              </a:ext>
            </a:extLst>
          </p:cNvPr>
          <p:cNvSpPr txBox="1"/>
          <p:nvPr/>
        </p:nvSpPr>
        <p:spPr>
          <a:xfrm>
            <a:off x="2161091" y="2077101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924EF60-5738-EEC3-1510-AFA9CD32C4FC}"/>
              </a:ext>
            </a:extLst>
          </p:cNvPr>
          <p:cNvSpPr txBox="1"/>
          <p:nvPr/>
        </p:nvSpPr>
        <p:spPr>
          <a:xfrm>
            <a:off x="2477179" y="2261767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CC0DEF6-AAF5-428B-B21F-850412AE8817}"/>
              </a:ext>
            </a:extLst>
          </p:cNvPr>
          <p:cNvSpPr txBox="1"/>
          <p:nvPr/>
        </p:nvSpPr>
        <p:spPr>
          <a:xfrm>
            <a:off x="2770688" y="2103857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929A34C-E90E-2A5A-5EF5-4204F655B880}"/>
              </a:ext>
            </a:extLst>
          </p:cNvPr>
          <p:cNvSpPr txBox="1"/>
          <p:nvPr/>
        </p:nvSpPr>
        <p:spPr>
          <a:xfrm>
            <a:off x="1033613" y="1061020"/>
            <a:ext cx="2119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Niben1.0Scf008g00467.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B444B73-2B2C-DF3F-9E0A-AD9CBA91F842}"/>
              </a:ext>
            </a:extLst>
          </p:cNvPr>
          <p:cNvSpPr txBox="1"/>
          <p:nvPr/>
        </p:nvSpPr>
        <p:spPr>
          <a:xfrm>
            <a:off x="4114074" y="1274436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53A6C77-6F94-7FDD-7941-BB6BB82FD255}"/>
              </a:ext>
            </a:extLst>
          </p:cNvPr>
          <p:cNvSpPr txBox="1"/>
          <p:nvPr/>
        </p:nvSpPr>
        <p:spPr>
          <a:xfrm>
            <a:off x="4424518" y="2171591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EB20AC0-5577-CA89-5AD4-C25A786B6A74}"/>
              </a:ext>
            </a:extLst>
          </p:cNvPr>
          <p:cNvSpPr txBox="1"/>
          <p:nvPr/>
        </p:nvSpPr>
        <p:spPr>
          <a:xfrm>
            <a:off x="4746267" y="2149013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63615F1-D931-1C6B-971A-EC67BDD81C9F}"/>
              </a:ext>
            </a:extLst>
          </p:cNvPr>
          <p:cNvSpPr txBox="1"/>
          <p:nvPr/>
        </p:nvSpPr>
        <p:spPr>
          <a:xfrm>
            <a:off x="5073548" y="2074007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43E8EB5-0E91-F2BD-DCBD-470305B81395}"/>
              </a:ext>
            </a:extLst>
          </p:cNvPr>
          <p:cNvSpPr txBox="1"/>
          <p:nvPr/>
        </p:nvSpPr>
        <p:spPr>
          <a:xfrm>
            <a:off x="5397962" y="1887358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FCE4E1B-D2FD-3185-54F5-962F5487F800}"/>
              </a:ext>
            </a:extLst>
          </p:cNvPr>
          <p:cNvSpPr txBox="1"/>
          <p:nvPr/>
        </p:nvSpPr>
        <p:spPr>
          <a:xfrm>
            <a:off x="3651878" y="1055948"/>
            <a:ext cx="2119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Niben1.0Scf015g01886.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图表 17">
            <a:extLst>
              <a:ext uri="{FF2B5EF4-FFF2-40B4-BE49-F238E27FC236}">
                <a16:creationId xmlns:a16="http://schemas.microsoft.com/office/drawing/2014/main" id="{D8FB58A2-DA21-1F84-C2FE-6BB1A148D1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6021608"/>
              </p:ext>
            </p:extLst>
          </p:nvPr>
        </p:nvGraphicFramePr>
        <p:xfrm>
          <a:off x="543228" y="4207729"/>
          <a:ext cx="2662877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文本框 18">
            <a:extLst>
              <a:ext uri="{FF2B5EF4-FFF2-40B4-BE49-F238E27FC236}">
                <a16:creationId xmlns:a16="http://schemas.microsoft.com/office/drawing/2014/main" id="{3DE81258-9E95-4632-1A55-945CAF699037}"/>
              </a:ext>
            </a:extLst>
          </p:cNvPr>
          <p:cNvSpPr txBox="1"/>
          <p:nvPr/>
        </p:nvSpPr>
        <p:spPr>
          <a:xfrm>
            <a:off x="1607935" y="5317349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A413E0F-22E6-739F-7A8B-91766CAE754D}"/>
              </a:ext>
            </a:extLst>
          </p:cNvPr>
          <p:cNvSpPr txBox="1"/>
          <p:nvPr/>
        </p:nvSpPr>
        <p:spPr>
          <a:xfrm>
            <a:off x="1912735" y="5346958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DB10E3B-EBA7-2BCC-109A-6AA4669DA43B}"/>
              </a:ext>
            </a:extLst>
          </p:cNvPr>
          <p:cNvSpPr txBox="1"/>
          <p:nvPr/>
        </p:nvSpPr>
        <p:spPr>
          <a:xfrm>
            <a:off x="2198175" y="5316143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36060E3-C8D7-574B-9B0C-0BF279307CE0}"/>
              </a:ext>
            </a:extLst>
          </p:cNvPr>
          <p:cNvSpPr txBox="1"/>
          <p:nvPr/>
        </p:nvSpPr>
        <p:spPr>
          <a:xfrm>
            <a:off x="2503685" y="5358247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2179E18-0258-F1CA-A9FA-132FDFD05B83}"/>
              </a:ext>
            </a:extLst>
          </p:cNvPr>
          <p:cNvSpPr txBox="1"/>
          <p:nvPr/>
        </p:nvSpPr>
        <p:spPr>
          <a:xfrm>
            <a:off x="2810993" y="5273794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FA7CE5FE-96E0-4616-1CA0-95D82C77FB33}"/>
              </a:ext>
            </a:extLst>
          </p:cNvPr>
          <p:cNvSpPr txBox="1"/>
          <p:nvPr/>
        </p:nvSpPr>
        <p:spPr>
          <a:xfrm>
            <a:off x="1093275" y="4070215"/>
            <a:ext cx="2119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Niben1.0Scf001g02043.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8" name="图表 27">
            <a:extLst>
              <a:ext uri="{FF2B5EF4-FFF2-40B4-BE49-F238E27FC236}">
                <a16:creationId xmlns:a16="http://schemas.microsoft.com/office/drawing/2014/main" id="{2A3E87C0-F606-C2AD-9E2B-F8A41C7E28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6614283"/>
              </p:ext>
            </p:extLst>
          </p:nvPr>
        </p:nvGraphicFramePr>
        <p:xfrm>
          <a:off x="3129826" y="4216643"/>
          <a:ext cx="2662878" cy="27557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9" name="文本框 28">
            <a:extLst>
              <a:ext uri="{FF2B5EF4-FFF2-40B4-BE49-F238E27FC236}">
                <a16:creationId xmlns:a16="http://schemas.microsoft.com/office/drawing/2014/main" id="{67C13CC3-DD2D-9769-2903-72F59D14F8FB}"/>
              </a:ext>
            </a:extLst>
          </p:cNvPr>
          <p:cNvSpPr txBox="1"/>
          <p:nvPr/>
        </p:nvSpPr>
        <p:spPr>
          <a:xfrm>
            <a:off x="3683787" y="4079305"/>
            <a:ext cx="2119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Niben1.0Scf012g01944.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A9364E1-1D9F-7A24-DE35-4F705D8360E1}"/>
              </a:ext>
            </a:extLst>
          </p:cNvPr>
          <p:cNvSpPr txBox="1"/>
          <p:nvPr/>
        </p:nvSpPr>
        <p:spPr>
          <a:xfrm>
            <a:off x="4194533" y="5351216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FCD6F98-F34B-6A88-189F-555CD2B88077}"/>
              </a:ext>
            </a:extLst>
          </p:cNvPr>
          <p:cNvSpPr txBox="1"/>
          <p:nvPr/>
        </p:nvSpPr>
        <p:spPr>
          <a:xfrm>
            <a:off x="4499333" y="5380825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610EFEB-206F-005B-8EC6-809EB7121167}"/>
              </a:ext>
            </a:extLst>
          </p:cNvPr>
          <p:cNvSpPr txBox="1"/>
          <p:nvPr/>
        </p:nvSpPr>
        <p:spPr>
          <a:xfrm>
            <a:off x="4784773" y="5350010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6F910BD-74EB-171F-5B94-C5CD4222D4C1}"/>
              </a:ext>
            </a:extLst>
          </p:cNvPr>
          <p:cNvSpPr txBox="1"/>
          <p:nvPr/>
        </p:nvSpPr>
        <p:spPr>
          <a:xfrm>
            <a:off x="5090283" y="5392114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493E9A29-506D-053C-F9D4-D057C6841252}"/>
              </a:ext>
            </a:extLst>
          </p:cNvPr>
          <p:cNvSpPr txBox="1"/>
          <p:nvPr/>
        </p:nvSpPr>
        <p:spPr>
          <a:xfrm>
            <a:off x="5397591" y="5307661"/>
            <a:ext cx="214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*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772758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D216A98F-44A4-1E49-B412-7AD632D93834}"/>
              </a:ext>
            </a:extLst>
          </p:cNvPr>
          <p:cNvGrpSpPr/>
          <p:nvPr/>
        </p:nvGrpSpPr>
        <p:grpSpPr>
          <a:xfrm>
            <a:off x="1303287" y="378379"/>
            <a:ext cx="4251426" cy="6751002"/>
            <a:chOff x="2450928" y="198764"/>
            <a:chExt cx="4251426" cy="6751002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D6F96426-15F1-5940-B804-BFC2E49329B4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63535" y="198764"/>
              <a:ext cx="1508400" cy="164520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40788965-8620-374F-84BE-AF569CA2CB63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143189" y="198765"/>
              <a:ext cx="1508400" cy="16452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1F44765D-6D8D-B245-968F-D325F6D562E3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61749" y="1842608"/>
              <a:ext cx="1508400" cy="1645200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C7E7D3A0-7567-654D-A0B6-E1BC1733AA86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50928" y="3641968"/>
              <a:ext cx="1508400" cy="164520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3ABDA918-1F48-D14A-9894-3590F14EEA7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450928" y="198768"/>
              <a:ext cx="1506854" cy="1643841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179A5191-017A-1942-8DA4-160B205A3320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96783" y="3650667"/>
              <a:ext cx="1508400" cy="16452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9F5F9CEC-7C46-664F-B210-29E3CCA20F10}"/>
                </a:ext>
              </a:extLst>
            </p:cNvPr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193064" y="3659366"/>
              <a:ext cx="1508400" cy="1645200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BCC74276-1001-D14F-B063-1996CBA6634A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880158" y="5304566"/>
              <a:ext cx="1508400" cy="164520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E3984DCC-F6BF-684E-8331-A669DA30376D}"/>
                </a:ext>
              </a:extLst>
            </p:cNvPr>
            <p:cNvPicPr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193954" y="5298766"/>
              <a:ext cx="1508400" cy="164520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65BD3F1D-541C-C449-A637-582435A8DE1C}"/>
                </a:ext>
              </a:extLst>
            </p:cNvPr>
            <p:cNvPicPr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896633" y="1877695"/>
              <a:ext cx="1508400" cy="1645200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246F0641-210C-8D4C-9D2D-79B843AD3D21}"/>
                </a:ext>
              </a:extLst>
            </p:cNvPr>
            <p:cNvPicPr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177329" y="1870375"/>
              <a:ext cx="1508400" cy="1645200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65049E8E-1C4F-A947-BFBF-022F754A919B}"/>
                </a:ext>
              </a:extLst>
            </p:cNvPr>
            <p:cNvPicPr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484178" y="5295867"/>
              <a:ext cx="1508400" cy="1645200"/>
            </a:xfrm>
            <a:prstGeom prst="rect">
              <a:avLst/>
            </a:prstGeom>
          </p:spPr>
        </p:pic>
      </p:grpSp>
      <p:sp>
        <p:nvSpPr>
          <p:cNvPr id="17" name="TextBox 1041">
            <a:extLst>
              <a:ext uri="{FF2B5EF4-FFF2-40B4-BE49-F238E27FC236}">
                <a16:creationId xmlns:a16="http://schemas.microsoft.com/office/drawing/2014/main" id="{F69E270C-AF9D-9644-AA29-CEE0BD820C84}"/>
              </a:ext>
            </a:extLst>
          </p:cNvPr>
          <p:cNvSpPr txBox="1"/>
          <p:nvPr/>
        </p:nvSpPr>
        <p:spPr>
          <a:xfrm>
            <a:off x="294148" y="7266142"/>
            <a:ext cx="6351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3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e FPKM of </a:t>
            </a:r>
            <a:r>
              <a:rPr lang="en-US" sz="1200" b="1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assinosteroids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b="1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ignalling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lated gene in </a:t>
            </a:r>
            <a:r>
              <a:rPr lang="en-US" altLang="zh-CN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WT and </a:t>
            </a:r>
            <a:r>
              <a:rPr lang="en-US" altLang="zh-CN" sz="1200" b="1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eNbSQS</a:t>
            </a:r>
            <a:r>
              <a:rPr lang="en-US" altLang="zh-CN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ines.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457485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19</TotalTime>
  <Words>104</Words>
  <Application>Microsoft Macintosh PowerPoint</Application>
  <PresentationFormat>信纸(8.5x11 英寸)</PresentationFormat>
  <Paragraphs>34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周 绍群</dc:creator>
  <cp:lastModifiedBy>1</cp:lastModifiedBy>
  <cp:revision>30</cp:revision>
  <dcterms:created xsi:type="dcterms:W3CDTF">2022-10-10T07:27:18Z</dcterms:created>
  <dcterms:modified xsi:type="dcterms:W3CDTF">2023-02-01T06:01:42Z</dcterms:modified>
</cp:coreProperties>
</file>